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47" d="100"/>
          <a:sy n="47" d="100"/>
        </p:scale>
        <p:origin x="9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6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827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656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148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252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1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995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93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569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35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028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63090-F0DE-4252-A1C9-0ED007A1C02E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A9AAA-B1FE-4F4B-94A1-AF23592F5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581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2" name="Picture 107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91" y="379552"/>
            <a:ext cx="4231364" cy="2739274"/>
          </a:xfrm>
          <a:prstGeom prst="rect">
            <a:avLst/>
          </a:prstGeom>
        </p:spPr>
      </p:pic>
      <p:pic>
        <p:nvPicPr>
          <p:cNvPr id="1073" name="Picture 107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379552"/>
            <a:ext cx="4197210" cy="271735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2729" y="4087906"/>
            <a:ext cx="739963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Concentration in GK 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re statistically significant for that sex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 Concentration in male and female are statistically significant for that phenotype (compares to corresponding moiety in panels A &amp; B)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§ The ANOVA interaction term is statistically significant (compares corresponding moiety in panels A &amp; 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4970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oresh Shoghi</dc:creator>
  <cp:lastModifiedBy>Kooresh Shoghi</cp:lastModifiedBy>
  <cp:revision>1</cp:revision>
  <dcterms:created xsi:type="dcterms:W3CDTF">2016-03-23T04:37:34Z</dcterms:created>
  <dcterms:modified xsi:type="dcterms:W3CDTF">2016-03-23T04:38:17Z</dcterms:modified>
</cp:coreProperties>
</file>